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0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83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BB4C9D3-851F-C764-724E-79A582CCC4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467AD3DF-A83B-1080-DC55-9B9C067BA6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33C8D320-7E96-3CBA-ABB1-2AC048724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077D04F9-B29F-CED2-12DE-E1747C591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3710161-D35F-2674-4862-4683B6ADC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547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C012C30-D96A-F3C0-BA19-4C3F655F3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B20B014D-3808-9C3D-772F-AEA70F223A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99F5807-BEC0-2F39-E47F-772C9F65F3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CDF4016-508E-2227-DD57-139649629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4BA9C74-3976-83F8-70FB-917CD9902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13333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0DE8FDE5-6D0E-68E3-133F-0331CEAC4F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10E921BA-445B-4EFE-603B-D6B5450C54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E45BAC40-0A20-D335-8A9D-F9C422CCF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D73296F7-A3C0-1A6D-5C64-0CDC973EA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9D0F686C-8C05-AEE8-A5FA-C8A29930A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59858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1D5695F-E5F9-5048-B82E-3D35AA26D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1D1D8DCC-AD64-7B2B-FD3E-3D7F2BECAE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57AA38D-3883-CCF9-E504-5F55E53EC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F788FF8-B407-AA17-92AD-804DF77D6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39851EF-670C-2516-FC3D-834F7C051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22708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300EF0C-2338-0E5B-69DB-B44B27F7A0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0D1F95EE-3A0A-563B-F8CB-948EC053CF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7BE6638-A5D7-96D6-4406-7C9D87202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4D665F2-32CE-6534-DF3D-0CA5BAFF3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4594F31-F302-1CFE-982E-3EE52C5E7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61435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D5E5F07-A87E-35DD-83F4-48F439D564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D4C6E19E-88C6-E469-8C85-7171B5E652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4481FE60-8AD3-0243-AD95-9FD77D283A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C31E5E4A-1652-CD9B-6CD1-ECCC93724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6F528674-0623-A6F5-790B-2F59F1416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ACE3198B-B8D1-EEA1-5D56-EC9AC90FF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20406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3887589-283E-B210-F038-9FF133205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F1BEEE5C-B33A-77CB-8399-B77194B3B9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EB9B1914-65F9-0C8C-A45C-DB266F5AE6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475E6E60-A986-EA01-0846-8628548BB4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F0926B32-DB7A-CD60-6252-4D5F024D68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1E71CA0F-06AC-499B-6E18-4AF822814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D7F94498-0D1D-5F71-577A-E362A82AF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9D9AE08E-6C6D-CCBC-5F3A-54FB86ABF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24787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AD60958-9D8B-C411-D60E-44443A38D2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D998E60B-8222-33EB-4A1C-77C37B75B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180FC83C-B2A0-7B6D-608D-733B6B8A1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2428037B-48D0-5BCE-1F99-FE93EC66E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25501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A5493212-83B1-313A-DBE6-75DB7DD90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471DF91E-A3A2-8E12-01A3-B7E1AAE0E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AC114216-F376-E02E-FF5D-D1CBCD63D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74398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A4EC5DD-FD70-92D1-2851-FC59D1CC4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7F1C4FC5-63B2-A4C7-E25B-81C60B19B7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7606BA53-9F47-F1B4-8B25-459E3AA08D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61CF1FD5-63CE-8AA0-6028-439971771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990704CB-1D63-3489-F42D-3783DC524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2C0447FE-4AFB-7658-2528-EE038615D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08631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F97BFA6-6928-9646-C1EF-7FB7C8B5B9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EDC6A220-BF8A-BDCD-DDD5-B577F4F4E2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02426B2D-BECB-3449-B96D-4E0C54ABFC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BFD7D378-8B1E-4FDB-9EFC-4AC2FF68C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82807816-9A6D-F94B-FB5B-F1B1634715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DFA176F-88D4-03C5-B9E2-7E6B451F8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0763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06207654-E8C6-76CE-7E1E-AB434A1555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55854F6-FFDA-CC86-141B-62B57235A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420AC40-6FAC-1AF7-515A-80F7021D61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CF0EF5-D7FC-46A1-AE05-528BA98075D8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003C911A-8373-C75B-6DCA-02CFCDFA7C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E381C10-66C7-E5AD-3C8A-CD22843559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87070F-8533-43AE-8373-AC1FC1C94F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03857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>
            <a:extLst>
              <a:ext uri="{FF2B5EF4-FFF2-40B4-BE49-F238E27FC236}">
                <a16:creationId xmlns:a16="http://schemas.microsoft.com/office/drawing/2014/main" id="{EC5B4DEC-2228-1ED5-314B-5C5E1A11DF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9909" y="473863"/>
            <a:ext cx="6184970" cy="3297162"/>
          </a:xfrm>
          <a:prstGeom prst="rect">
            <a:avLst/>
          </a:prstGeom>
        </p:spPr>
      </p:pic>
      <p:sp>
        <p:nvSpPr>
          <p:cNvPr id="3" name="Szövegdoboz 2">
            <a:extLst>
              <a:ext uri="{FF2B5EF4-FFF2-40B4-BE49-F238E27FC236}">
                <a16:creationId xmlns:a16="http://schemas.microsoft.com/office/drawing/2014/main" id="{A8B86037-C7D4-C107-AC1C-F0D993EACBF9}"/>
              </a:ext>
            </a:extLst>
          </p:cNvPr>
          <p:cNvSpPr txBox="1"/>
          <p:nvPr/>
        </p:nvSpPr>
        <p:spPr>
          <a:xfrm>
            <a:off x="345953" y="4729722"/>
            <a:ext cx="1136213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hu-HU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GB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hu-HU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lete</a:t>
            </a:r>
            <a:r>
              <a:rPr lang="hu-H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sence</a:t>
            </a:r>
            <a:r>
              <a:rPr lang="hu-H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cium</a:t>
            </a:r>
            <a:r>
              <a:rPr lang="hu-H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ients</a:t>
            </a:r>
            <a:r>
              <a:rPr lang="hu-H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hu-HU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ymatically</a:t>
            </a:r>
            <a:r>
              <a:rPr lang="hu-H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lated</a:t>
            </a:r>
            <a:r>
              <a:rPr lang="hu-H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DB </a:t>
            </a:r>
            <a:r>
              <a:rPr lang="hu-HU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ers</a:t>
            </a:r>
            <a:r>
              <a:rPr lang="hu-H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hu-H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er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aded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ra2-AM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es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obal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ient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mation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on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ministration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Yoda1.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Cl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itability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ers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endParaRPr lang="hu-H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9696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2</Words>
  <Application>Microsoft Office PowerPoint</Application>
  <PresentationFormat>Szélesvásznú</PresentationFormat>
  <Paragraphs>2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atrix Dienes</dc:creator>
  <cp:lastModifiedBy>Beatrix Dienes</cp:lastModifiedBy>
  <cp:revision>3</cp:revision>
  <dcterms:created xsi:type="dcterms:W3CDTF">2026-01-26T12:16:40Z</dcterms:created>
  <dcterms:modified xsi:type="dcterms:W3CDTF">2026-06-19T13:55:34Z</dcterms:modified>
</cp:coreProperties>
</file>